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71" r:id="rId3"/>
    <p:sldId id="268" r:id="rId4"/>
    <p:sldId id="269" r:id="rId5"/>
    <p:sldId id="273" r:id="rId6"/>
  </p:sldIdLst>
  <p:sldSz cx="12192000" cy="6858000"/>
  <p:notesSz cx="6858000" cy="9144000"/>
  <p:defaultTextStyle>
    <a:defPPr>
      <a:defRPr lang="en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10"/>
    <p:restoredTop sz="95788"/>
  </p:normalViewPr>
  <p:slideViewPr>
    <p:cSldViewPr snapToGrid="0" showGuides="1">
      <p:cViewPr varScale="1">
        <p:scale>
          <a:sx n="88" d="100"/>
          <a:sy n="88" d="100"/>
        </p:scale>
        <p:origin x="186" y="7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B0C6AB1-D2C9-1AEE-32A5-8182AD96943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DE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53B8DBE-435B-F684-D6C8-15E099337C8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E7DA291-5C9D-4126-237F-E49E817A8A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BB67D-4D83-0C41-BF7A-FF66018180F0}" type="datetimeFigureOut">
              <a:rPr lang="en-DE" smtClean="0"/>
              <a:t>03/06/2023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FDF4CE3-2148-3AD2-F85F-94E996AB9E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751D43F-47E7-DF13-FDC0-A8D67D3C17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410573-9F2D-F844-80C9-741A38831E56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7842287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91F864F-2691-BB14-E2E0-96201A20B65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D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D86DE7B-0741-FE8C-ECDF-A59D3355660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AAE219C-8509-0FA8-88B0-A0052092A8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BB67D-4D83-0C41-BF7A-FF66018180F0}" type="datetimeFigureOut">
              <a:rPr lang="en-DE" smtClean="0"/>
              <a:t>03/06/2023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D75757C-6774-A85C-8BFA-85099A554A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9DAADC3-995C-CA7A-247E-B539AD9467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410573-9F2D-F844-80C9-741A38831E56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9724695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BF84F6C-598C-446B-D767-8995B336684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D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11EBCC7-D793-1318-00BE-DA3AE553DDE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DD193A0-A1CC-93AB-43B0-8BE6CBE0CC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BB67D-4D83-0C41-BF7A-FF66018180F0}" type="datetimeFigureOut">
              <a:rPr lang="en-DE" smtClean="0"/>
              <a:t>03/06/2023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10AC4A1-2E86-3E87-787F-F713EAAD1D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7898F52-A831-69F9-A361-FCF744AABF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410573-9F2D-F844-80C9-741A38831E56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8028394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8B0546D-5603-4E87-D33F-D7514AE08A7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875AF95-07D6-F83A-5C66-ADB0BA50C9A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86B880D-D49D-1E19-946E-CA3CD67D79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BB67D-4D83-0C41-BF7A-FF66018180F0}" type="datetimeFigureOut">
              <a:rPr lang="en-DE" smtClean="0"/>
              <a:t>03/06/2023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49CCA55-6E96-A5BD-D96B-50B0321D40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BF1E879-13BF-46A2-250A-FE36CF2761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410573-9F2D-F844-80C9-741A38831E56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5544248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2485DEE-CD0D-63C6-9F08-C4FF2BD4A61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6D735BD-AD71-CF91-E6A3-DCDA148E9ED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C86A1F4-5EC2-9718-4052-9B2773E6E1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BB67D-4D83-0C41-BF7A-FF66018180F0}" type="datetimeFigureOut">
              <a:rPr lang="en-DE" smtClean="0"/>
              <a:t>03/06/2023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F04303E-3713-D743-D5C1-74623E35AA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5B4B873-FB10-0D3E-1E8D-6AD587A81C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410573-9F2D-F844-80C9-741A38831E56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9892196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2EDD8D9-59BD-1F7D-B0F6-306337042C5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7722EA3-F90B-00B0-4A35-E4FB8EA66DB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DE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28AB9DC-C293-1A1A-355B-45BC6BE05B1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DE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76DA33C-E0C8-7F68-44F5-FE1D5F5114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BB67D-4D83-0C41-BF7A-FF66018180F0}" type="datetimeFigureOut">
              <a:rPr lang="en-DE" smtClean="0"/>
              <a:t>03/06/2023</a:t>
            </a:fld>
            <a:endParaRPr lang="en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4C8F3C5-89C7-F1D7-5839-492B1FA706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DD807B9-4D3A-936D-8097-83095D629C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410573-9F2D-F844-80C9-741A38831E56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3521334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F5D8977-9D18-23BC-116A-24A6A42A167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C5E3A6E-359D-A4A5-CCCF-BB8EFC588F7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1D02207-5348-096D-6085-A2FF2EACD2F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DE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D7572AE-9290-D44B-9EB3-0845081192A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4F95B51-328B-44FD-8C26-B90FAA96182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DE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0E5B493-110E-2F9D-7867-A2319C1162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BB67D-4D83-0C41-BF7A-FF66018180F0}" type="datetimeFigureOut">
              <a:rPr lang="en-DE" smtClean="0"/>
              <a:t>03/06/2023</a:t>
            </a:fld>
            <a:endParaRPr lang="en-DE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B683F8B-4C32-A586-789E-E052941FBB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29E3826-080F-848A-F4B4-A48EC00E8E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410573-9F2D-F844-80C9-741A38831E56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8056160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7B8EDC2-21F0-10E2-4B5E-C29D3FAFFA4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DE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C0AA038-8F71-53A4-7C90-AC640F279D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BB67D-4D83-0C41-BF7A-FF66018180F0}" type="datetimeFigureOut">
              <a:rPr lang="en-DE" smtClean="0"/>
              <a:t>03/06/2023</a:t>
            </a:fld>
            <a:endParaRPr lang="en-DE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BA78A12-35BF-255C-632E-F9537D31AA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4AD5305-E078-42D7-B100-35BC26A2B0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410573-9F2D-F844-80C9-741A38831E56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4646919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746C2D9-216E-B29E-6C2C-9554371CED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BB67D-4D83-0C41-BF7A-FF66018180F0}" type="datetimeFigureOut">
              <a:rPr lang="en-DE" smtClean="0"/>
              <a:t>03/06/2023</a:t>
            </a:fld>
            <a:endParaRPr lang="en-D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69801DA-118B-C540-8459-B8E16984E7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A38F5C6-4FDC-7056-3E25-6015EF8275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410573-9F2D-F844-80C9-741A38831E56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41885532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5D3067C-C631-A6D4-3BF7-A7062710212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3DB952B-B016-4248-2C70-1F299AACA73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D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2E23873-F0FD-6E7F-0713-CF34C9695A4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DD3A86E-0D15-C472-7C4C-5EE8092F5B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BB67D-4D83-0C41-BF7A-FF66018180F0}" type="datetimeFigureOut">
              <a:rPr lang="en-DE" smtClean="0"/>
              <a:t>03/06/2023</a:t>
            </a:fld>
            <a:endParaRPr lang="en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EE540E0-9157-19AD-4605-37DE39D5DB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B41ED56-6D5F-6A35-621D-5A54FC95F4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410573-9F2D-F844-80C9-741A38831E56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3202320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D817688-DCCA-CE66-392D-2CD3CB0E5F8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DE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F3823C2-BD52-F75E-EACB-1A42897254B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D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B9EF500-8495-37A6-53CA-32466DDBA39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688AEFE-84BF-AB20-2DA6-69BC2C4952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BB67D-4D83-0C41-BF7A-FF66018180F0}" type="datetimeFigureOut">
              <a:rPr lang="en-DE" smtClean="0"/>
              <a:t>03/06/2023</a:t>
            </a:fld>
            <a:endParaRPr lang="en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6AA37C0-6151-B5B0-15AF-7A9D48254B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1D1C1F5-112C-D4AE-6275-B7E740B12E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410573-9F2D-F844-80C9-741A38831E56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3763555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D236E29-1B96-BE2A-579B-9C0EAD2373C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2D6D2B4-91DF-7A05-D73B-4269A4513EE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0BDC84A-F90B-07E2-4DA4-7F34C77F48D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3BB67D-4D83-0C41-BF7A-FF66018180F0}" type="datetimeFigureOut">
              <a:rPr lang="en-DE" smtClean="0"/>
              <a:t>03/06/2023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EAF9A27-09DB-070C-90EF-96F7DC6B903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452BD3E-A026-1B2D-6508-C1F451E53BB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410573-9F2D-F844-80C9-741A38831E56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41515000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sv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5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9.png"/><Relationship Id="rId4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ubtitle 2">
            <a:extLst>
              <a:ext uri="{FF2B5EF4-FFF2-40B4-BE49-F238E27FC236}">
                <a16:creationId xmlns:a16="http://schemas.microsoft.com/office/drawing/2014/main" id="{EFA189AF-3A42-6A76-E31A-964D0EF750DA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en-DE" dirty="0"/>
              <a:t>Supplementary Figures</a:t>
            </a:r>
          </a:p>
        </p:txBody>
      </p:sp>
    </p:spTree>
    <p:extLst>
      <p:ext uri="{BB962C8B-B14F-4D97-AF65-F5344CB8AC3E}">
        <p14:creationId xmlns:p14="http://schemas.microsoft.com/office/powerpoint/2010/main" val="220861160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C890A837-0F0A-4C59-BCFE-EBE0CDDCFE23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196" y="914395"/>
            <a:ext cx="3657607" cy="5029210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1563077" y="578338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Figure S1</a:t>
            </a:r>
            <a:endParaRPr lang="en-US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7FB849B5-859E-66A3-AA0C-985AF472A30F}"/>
              </a:ext>
            </a:extLst>
          </p:cNvPr>
          <p:cNvSpPr txBox="1"/>
          <p:nvPr/>
        </p:nvSpPr>
        <p:spPr>
          <a:xfrm>
            <a:off x="4267196" y="778393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6423A697-D343-2115-15EA-CA4CF16B6EE2}"/>
              </a:ext>
            </a:extLst>
          </p:cNvPr>
          <p:cNvSpPr txBox="1"/>
          <p:nvPr/>
        </p:nvSpPr>
        <p:spPr>
          <a:xfrm>
            <a:off x="2842751" y="5939702"/>
            <a:ext cx="843371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Sup Fig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1: Protein abundance alt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rations in PVB vs Cntrls in Upper and Lower lobes compared to Lung matrisome data.</a:t>
            </a:r>
          </a:p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Only proteins with adj 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&lt;</a:t>
            </a:r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 0.05 in at least one tissue. Circles size corelate with Benjamini Hochberg adjusted 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 value.</a:t>
            </a:r>
          </a:p>
        </p:txBody>
      </p:sp>
    </p:spTree>
    <p:extLst>
      <p:ext uri="{BB962C8B-B14F-4D97-AF65-F5344CB8AC3E}">
        <p14:creationId xmlns:p14="http://schemas.microsoft.com/office/powerpoint/2010/main" val="48263949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636BD4FC-D7A3-4815-AEA6-31F283A70B04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65969" y="43033"/>
            <a:ext cx="5720862" cy="6814968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F3984924-89E1-4560-ADC1-0923192F1B12}"/>
              </a:ext>
            </a:extLst>
          </p:cNvPr>
          <p:cNvSpPr txBox="1"/>
          <p:nvPr/>
        </p:nvSpPr>
        <p:spPr>
          <a:xfrm>
            <a:off x="791166" y="475488"/>
            <a:ext cx="10953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Figure  S2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0D89880F-A831-3668-AD03-D031F1C50F73}"/>
              </a:ext>
            </a:extLst>
          </p:cNvPr>
          <p:cNvSpPr txBox="1"/>
          <p:nvPr/>
        </p:nvSpPr>
        <p:spPr>
          <a:xfrm>
            <a:off x="6002887" y="136934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25E2594F-A36C-BD5C-59A9-1E65C7B5E4D5}"/>
              </a:ext>
            </a:extLst>
          </p:cNvPr>
          <p:cNvSpPr txBox="1"/>
          <p:nvPr/>
        </p:nvSpPr>
        <p:spPr>
          <a:xfrm>
            <a:off x="6002887" y="3719883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85969" y="2526571"/>
            <a:ext cx="4987846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2.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Metabolomic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analysis in the lower lobe of PVB vs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Cntrl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animals. (A) Metabolites ranked by Variable importance in the projection score (VIP)&gt;1 in PVB vs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Cntrl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pigs in upper lobes based on OPL- DA analysis. (B) Pathway analysis based on KEGG database of the enriched metabolites (VIP&gt;1 and p value &lt;0.05 in the lower lobe PVB vs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Cntrl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swine. n=6 in each group. The size of the dots represents the enrichment ratio and the shade of the color represent the -log 10(p value).</a:t>
            </a:r>
          </a:p>
          <a:p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62288107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Graphic 2">
            <a:extLst>
              <a:ext uri="{FF2B5EF4-FFF2-40B4-BE49-F238E27FC236}">
                <a16:creationId xmlns:a16="http://schemas.microsoft.com/office/drawing/2014/main" id="{3DFDE9A4-DC05-48C7-9AD0-55B038A865FF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rcRect t="2909" r="3309"/>
          <a:stretch/>
        </p:blipFill>
        <p:spPr>
          <a:xfrm>
            <a:off x="92598" y="-1"/>
            <a:ext cx="7347824" cy="6858001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707858B9-35D1-496F-A31F-6126A1A3BAFD}"/>
              </a:ext>
            </a:extLst>
          </p:cNvPr>
          <p:cNvSpPr txBox="1"/>
          <p:nvPr/>
        </p:nvSpPr>
        <p:spPr>
          <a:xfrm>
            <a:off x="53283" y="0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Figure S3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A9BA467C-3476-862B-45D4-8AA690990B97}"/>
              </a:ext>
            </a:extLst>
          </p:cNvPr>
          <p:cNvSpPr txBox="1"/>
          <p:nvPr/>
        </p:nvSpPr>
        <p:spPr>
          <a:xfrm>
            <a:off x="1650526" y="1044000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DF06ECC3-1CF1-959F-A1E3-02754AF523C4}"/>
              </a:ext>
            </a:extLst>
          </p:cNvPr>
          <p:cNvSpPr txBox="1"/>
          <p:nvPr/>
        </p:nvSpPr>
        <p:spPr>
          <a:xfrm>
            <a:off x="7387512" y="1062049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99A1364A-5435-0DA9-6E4F-FF67F170ACEE}"/>
              </a:ext>
            </a:extLst>
          </p:cNvPr>
          <p:cNvSpPr txBox="1"/>
          <p:nvPr/>
        </p:nvSpPr>
        <p:spPr>
          <a:xfrm>
            <a:off x="5422739" y="4583916"/>
            <a:ext cx="6769261" cy="230832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FigureS3</a:t>
            </a:r>
            <a:r>
              <a:rPr lang="en-US" sz="1200" b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: Biological network analysis of the metabolites and proteins from metabolomics and proteomics</a:t>
            </a:r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. (A,) Metabolite-metabolite interaction network for the most enriched metabolites in the lower lobe PVB vs </a:t>
            </a:r>
            <a:r>
              <a:rPr lang="en-US" sz="12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Cntrl</a:t>
            </a:r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for Upper lobe. Labelled and red filled circles represent the upregulated metabolites detected in the PVB group (B) Gene- metabolite network analysis for the significantly altered proteins and enriched metabolites for upper lobe PVB vs </a:t>
            </a:r>
            <a:r>
              <a:rPr lang="en-US" sz="12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Cntrl</a:t>
            </a:r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. The red filled circles represent the upregulated metabolites and green filled circles represent the downregulated proteins detected in the PVB group. Metabolites of VIP&gt;1 with </a:t>
            </a:r>
            <a:r>
              <a:rPr lang="en-US" sz="12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pvalue</a:t>
            </a:r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&lt;0.05 and proteins with fold-change &gt; 1.3 and </a:t>
            </a:r>
            <a:r>
              <a:rPr lang="en-US" sz="12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Benjamini</a:t>
            </a:r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-Hochberg-adjusted p-value &lt; 0.05 were used for the analysis. </a:t>
            </a:r>
            <a:endParaRPr lang="en-DE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grpSp>
        <p:nvGrpSpPr>
          <p:cNvPr id="12" name="Group 11">
            <a:extLst>
              <a:ext uri="{FF2B5EF4-FFF2-40B4-BE49-F238E27FC236}">
                <a16:creationId xmlns:a16="http://schemas.microsoft.com/office/drawing/2014/main" id="{88E7F0CF-BBD0-76EA-B52C-B89F769B369F}"/>
              </a:ext>
            </a:extLst>
          </p:cNvPr>
          <p:cNvGrpSpPr/>
          <p:nvPr/>
        </p:nvGrpSpPr>
        <p:grpSpPr>
          <a:xfrm>
            <a:off x="7719654" y="1"/>
            <a:ext cx="4472346" cy="4479830"/>
            <a:chOff x="7719654" y="830619"/>
            <a:chExt cx="3624044" cy="3649211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899D6E76-A0D9-44EF-9068-7121A5FA7BF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5086" t="22998" r="22070" b="23791"/>
            <a:stretch/>
          </p:blipFill>
          <p:spPr>
            <a:xfrm>
              <a:off x="7719654" y="830619"/>
              <a:ext cx="3624044" cy="3649211"/>
            </a:xfrm>
            <a:prstGeom prst="rect">
              <a:avLst/>
            </a:prstGeom>
          </p:spPr>
        </p:pic>
        <p:sp>
          <p:nvSpPr>
            <p:cNvPr id="9" name="Oval 8">
              <a:extLst>
                <a:ext uri="{FF2B5EF4-FFF2-40B4-BE49-F238E27FC236}">
                  <a16:creationId xmlns:a16="http://schemas.microsoft.com/office/drawing/2014/main" id="{0EBD5DB7-F336-D3C5-5285-5F32AD5AF272}"/>
                </a:ext>
              </a:extLst>
            </p:cNvPr>
            <p:cNvSpPr/>
            <p:nvPr/>
          </p:nvSpPr>
          <p:spPr>
            <a:xfrm>
              <a:off x="8616724" y="1434265"/>
              <a:ext cx="179070" cy="183600"/>
            </a:xfrm>
            <a:prstGeom prst="ellipse">
              <a:avLst/>
            </a:prstGeom>
            <a:solidFill>
              <a:srgbClr val="92D05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DE"/>
            </a:p>
          </p:txBody>
        </p:sp>
        <p:sp>
          <p:nvSpPr>
            <p:cNvPr id="10" name="Oval 9">
              <a:extLst>
                <a:ext uri="{FF2B5EF4-FFF2-40B4-BE49-F238E27FC236}">
                  <a16:creationId xmlns:a16="http://schemas.microsoft.com/office/drawing/2014/main" id="{EA50EEE7-7013-8DDE-2D4D-BE47468EF681}"/>
                </a:ext>
              </a:extLst>
            </p:cNvPr>
            <p:cNvSpPr/>
            <p:nvPr/>
          </p:nvSpPr>
          <p:spPr>
            <a:xfrm>
              <a:off x="10354856" y="2471624"/>
              <a:ext cx="179070" cy="183600"/>
            </a:xfrm>
            <a:prstGeom prst="ellipse">
              <a:avLst/>
            </a:prstGeom>
            <a:solidFill>
              <a:srgbClr val="92D05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DE"/>
            </a:p>
          </p:txBody>
        </p:sp>
        <p:sp>
          <p:nvSpPr>
            <p:cNvPr id="11" name="Oval 10">
              <a:extLst>
                <a:ext uri="{FF2B5EF4-FFF2-40B4-BE49-F238E27FC236}">
                  <a16:creationId xmlns:a16="http://schemas.microsoft.com/office/drawing/2014/main" id="{7BB45095-EE75-1B63-1BA5-0D2F84D873C2}"/>
                </a:ext>
              </a:extLst>
            </p:cNvPr>
            <p:cNvSpPr/>
            <p:nvPr/>
          </p:nvSpPr>
          <p:spPr>
            <a:xfrm>
              <a:off x="8250194" y="4203221"/>
              <a:ext cx="179070" cy="183600"/>
            </a:xfrm>
            <a:prstGeom prst="ellipse">
              <a:avLst/>
            </a:prstGeom>
            <a:solidFill>
              <a:srgbClr val="92D05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DE"/>
            </a:p>
          </p:txBody>
        </p:sp>
      </p:grpSp>
    </p:spTree>
    <p:extLst>
      <p:ext uri="{BB962C8B-B14F-4D97-AF65-F5344CB8AC3E}">
        <p14:creationId xmlns:p14="http://schemas.microsoft.com/office/powerpoint/2010/main" val="222423129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6D2C2C87-D582-441E-04EE-5EBB47C1BE0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04967" y="1274451"/>
            <a:ext cx="2286000" cy="223520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015FE666-2603-E63E-63A3-E643E1BF523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02285" y="1274451"/>
            <a:ext cx="2273300" cy="223520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F6F8C15F-FC68-6531-616F-11E74B37A123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30367" y="3678287"/>
            <a:ext cx="2235200" cy="223520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33AA81E8-589D-C423-23CB-0AD1DC5B4507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70080" y="3678287"/>
            <a:ext cx="2311400" cy="2235200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592CB7F7-CC03-5A80-6AD2-D8EFC0B4DF61}"/>
              </a:ext>
            </a:extLst>
          </p:cNvPr>
          <p:cNvSpPr txBox="1"/>
          <p:nvPr/>
        </p:nvSpPr>
        <p:spPr>
          <a:xfrm>
            <a:off x="801850" y="461287"/>
            <a:ext cx="10953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Figure  S4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142B4254-B2EB-83D3-0131-AB8F423E416D}"/>
              </a:ext>
            </a:extLst>
          </p:cNvPr>
          <p:cNvSpPr txBox="1"/>
          <p:nvPr/>
        </p:nvSpPr>
        <p:spPr>
          <a:xfrm>
            <a:off x="3298225" y="1213277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4C23D863-EDF8-C3ED-7948-5403E1693E6B}"/>
              </a:ext>
            </a:extLst>
          </p:cNvPr>
          <p:cNvSpPr txBox="1"/>
          <p:nvPr/>
        </p:nvSpPr>
        <p:spPr>
          <a:xfrm>
            <a:off x="6197709" y="3678287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6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78EC6670-2E5D-4AFE-1C30-92BA410923A2}"/>
              </a:ext>
            </a:extLst>
          </p:cNvPr>
          <p:cNvSpPr txBox="1"/>
          <p:nvPr/>
        </p:nvSpPr>
        <p:spPr>
          <a:xfrm>
            <a:off x="6197709" y="1210902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8040A086-4FF7-C8C6-5F77-F0EF587917BE}"/>
              </a:ext>
            </a:extLst>
          </p:cNvPr>
          <p:cNvSpPr txBox="1"/>
          <p:nvPr/>
        </p:nvSpPr>
        <p:spPr>
          <a:xfrm>
            <a:off x="3468529" y="3662195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6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3D73D5E5-8C58-31B2-E776-D71EB106F539}"/>
              </a:ext>
            </a:extLst>
          </p:cNvPr>
          <p:cNvSpPr txBox="1"/>
          <p:nvPr/>
        </p:nvSpPr>
        <p:spPr>
          <a:xfrm>
            <a:off x="258793" y="3590300"/>
            <a:ext cx="3219875" cy="157889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</a:pPr>
            <a:r>
              <a:rPr lang="en-DE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Sup Figure </a:t>
            </a:r>
            <a:r>
              <a:rPr lang="de-DE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S</a:t>
            </a:r>
            <a:r>
              <a:rPr lang="en-DE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4</a:t>
            </a:r>
            <a:r>
              <a:rPr lang="en-DE" sz="1200" b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: Fatty acid uptake members in the lower lobe </a:t>
            </a:r>
            <a:r>
              <a:rPr lang="en-DE" sz="1200" b="1" dirty="0">
                <a:latin typeface="Arial" panose="020B0604020202020204" pitchFamily="34" charset="0"/>
                <a:ea typeface="Times New Roman" panose="02020603050405020304" pitchFamily="18" charset="0"/>
              </a:rPr>
              <a:t>at </a:t>
            </a:r>
            <a:r>
              <a:rPr lang="en-DE" sz="1200" b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mRNA level</a:t>
            </a:r>
            <a:r>
              <a:rPr lang="en-DE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(A-D) mRNA level of APOA, APOE, CD36 and LDLR respectively are expressed relative to the mean expression of the sham animals (Values are mean +/- SEM. *p&lt;0.05, ***p&lt;0.001 two tailed n=5 animals per group)</a:t>
            </a:r>
            <a:endParaRPr lang="en-DE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358676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61</Words>
  <Application>Microsoft Office PowerPoint</Application>
  <PresentationFormat>Widescreen</PresentationFormat>
  <Paragraphs>19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yel Sen</dc:creator>
  <cp:lastModifiedBy>MDPI</cp:lastModifiedBy>
  <cp:revision>4</cp:revision>
  <dcterms:created xsi:type="dcterms:W3CDTF">2022-12-22T15:43:23Z</dcterms:created>
  <dcterms:modified xsi:type="dcterms:W3CDTF">2023-03-06T02:01:38Z</dcterms:modified>
</cp:coreProperties>
</file>